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5" autoAdjust="0"/>
    <p:restoredTop sz="94660"/>
  </p:normalViewPr>
  <p:slideViewPr>
    <p:cSldViewPr snapToGrid="0">
      <p:cViewPr varScale="1">
        <p:scale>
          <a:sx n="85" d="100"/>
          <a:sy n="85" d="100"/>
        </p:scale>
        <p:origin x="48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69D06B-8020-40B6-8208-98A046C107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568A30C-EF89-4A02-9B62-7B52320F00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6671F4-3E81-4534-B581-F5B5A0355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1CE4-0095-4047-BE32-0373DC8AF2CC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7BA81F-37D3-4A61-9BB8-0FDC3CDDD8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93F372-6BB0-4037-B73D-BB68BCE3CC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4CC71-D835-4916-B768-C66C4581F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9382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B54B92-C9D0-4535-990A-668C6F730D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16DF39E-6A1E-40B5-BFC4-9586C78906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66108E3-1191-4C00-AB19-EB2FB3711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1CE4-0095-4047-BE32-0373DC8AF2CC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05F080-8E4D-4A89-942D-7273F7958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768CBE-D0AC-420C-84D2-EE76DA49F7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4CC71-D835-4916-B768-C66C4581F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1655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D2C12DC-96C8-4491-8A3A-06E7AF8C3A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2D0FF92-1CE7-48E8-B9BB-B4DEAF9D60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4D9F57C-2E1C-4DE5-9CCC-EC1253DB8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1CE4-0095-4047-BE32-0373DC8AF2CC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716FBCA-0E03-46E9-9946-AB587DE24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4414DFF-7831-49AD-AF07-A76FC7FDB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4CC71-D835-4916-B768-C66C4581F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6271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0860E8-9B7C-4705-BB0C-F67247F74C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4216439-45E9-4310-A409-CEAF4898AC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79EF9F-8E34-4058-AA9A-91E834E1C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1CE4-0095-4047-BE32-0373DC8AF2CC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64E0E4E-B643-4558-A7AE-025A13BE52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6C769F8-11ED-46B4-96DE-F143C078B0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4CC71-D835-4916-B768-C66C4581F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2322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9942AF-EE40-4E49-AEF0-6254F41E99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9B720BF-D83F-4B9E-A697-EEA75B9B7D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912EA0-A15A-4DEE-9577-54C05E82F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1CE4-0095-4047-BE32-0373DC8AF2CC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CA7C3CA-4B16-402E-BD9D-C39CFCB82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C7A441-9430-494E-95B1-40D152432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4CC71-D835-4916-B768-C66C4581F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1021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E71220-70C6-42E9-968F-E888CA76AA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69D2EF2-B2D9-4885-A5C4-BF0E06E4EC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C0B1EFA-1E3C-4ECA-A398-2052DF2B93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90DD43-8F9F-43D9-8773-4A048BDB4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1CE4-0095-4047-BE32-0373DC8AF2CC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7E3E89E-20CF-470A-B091-459EA8B6B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0ACB107-FBBA-4EB4-B1DF-4C2911C2C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4CC71-D835-4916-B768-C66C4581F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373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A25F10-D456-4BE3-8DBF-D2F8B92BA8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93B3D8D-68E4-4AED-8B73-40FE27A7DF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62F83C9-CCEE-406C-B1D1-AF10875491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F783210-AB0C-4A6D-84E9-27FFFD793D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D549CE4-B9A1-4B98-BA6C-8CE122BF61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01A6812-5538-4687-9944-D9AD48925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1CE4-0095-4047-BE32-0373DC8AF2CC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04B6AA6-F523-407F-9EEF-14A10C5E9E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96ECA92-0F30-42FE-9E0F-EDF3014EF6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4CC71-D835-4916-B768-C66C4581F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6540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7AF50C-1FDE-40AE-92DA-EBD698614B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FBB87F2-E30D-4906-828C-D72DB57F1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1CE4-0095-4047-BE32-0373DC8AF2CC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409D680-5CD3-4E66-818E-C64DDF98A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C79A351-F1A5-4C19-9F7A-E62A40585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4CC71-D835-4916-B768-C66C4581F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448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B1DF083-A894-4A47-9902-3561A08FC8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1CE4-0095-4047-BE32-0373DC8AF2CC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C353CD2-5F16-4584-8A7B-272603C47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6E8077E-8E60-45FB-B1B1-10206156D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4CC71-D835-4916-B768-C66C4581F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76122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8FCB9C-90CC-42C8-BC9D-4989E572D6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2BB7385-61D9-45E5-95DA-21D10C40DA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133DD75-E164-46EB-AD02-EE7CAA88C1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FEE340E-5CC6-4088-B783-4DD588C2D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1CE4-0095-4047-BE32-0373DC8AF2CC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3C09222-8FCF-4618-B00A-BC5F5CA50E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89F06F7-13E1-43EA-8E56-6EFFE1872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4CC71-D835-4916-B768-C66C4581F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0197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9C2EDC-C500-4A25-B543-56C04C1DEB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79A992C-7611-40C3-8B5C-4B727FBB9D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7B3FA95-D13D-471B-8289-6F7212FEC1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EF67078-96E0-400E-9898-0ADFDE085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1CE4-0095-4047-BE32-0373DC8AF2CC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19254E3-6178-4F11-B8D3-F2921A8DEE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96A0003-6224-443F-A325-085979952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4CC71-D835-4916-B768-C66C4581F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4451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210B0F6-E755-4276-BD7A-988F097D5B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9FEF100-E1BA-440D-9AA5-3DC54F1097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C3AEB4-1006-43F6-83F9-A789A9AEB4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2F1CE4-0095-4047-BE32-0373DC8AF2CC}" type="datetimeFigureOut">
              <a:rPr lang="zh-CN" altLang="en-US" smtClean="0"/>
              <a:t>2022/4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5E884D6-D161-4A5E-AE57-BF24EE3D1C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D02CA2-4CDE-4EA8-8257-FC24AE8859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84CC71-D835-4916-B768-C66C4581F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4784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4B6527B-6B6F-4ECF-BCD9-E0723D3AD8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966" y="751715"/>
            <a:ext cx="3847112" cy="258191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C877AF3-F2A1-4896-ACAE-D3B45A22FA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2199" y="768546"/>
            <a:ext cx="3887601" cy="2581917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10B7F048-D95E-447D-BEAB-BF3EC2912E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03921" y="789343"/>
            <a:ext cx="3802747" cy="254429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F340030B-B7C3-42AD-945B-1B3A17902E65}"/>
              </a:ext>
            </a:extLst>
          </p:cNvPr>
          <p:cNvSpPr txBox="1"/>
          <p:nvPr/>
        </p:nvSpPr>
        <p:spPr>
          <a:xfrm>
            <a:off x="319760" y="499274"/>
            <a:ext cx="2468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17952BC-E263-4D2F-8B1F-6AA13E719248}"/>
              </a:ext>
            </a:extLst>
          </p:cNvPr>
          <p:cNvSpPr txBox="1"/>
          <p:nvPr/>
        </p:nvSpPr>
        <p:spPr>
          <a:xfrm>
            <a:off x="4229260" y="488990"/>
            <a:ext cx="2468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548A184-5E13-43DB-95BB-908B12C9ABA6}"/>
              </a:ext>
            </a:extLst>
          </p:cNvPr>
          <p:cNvSpPr txBox="1"/>
          <p:nvPr/>
        </p:nvSpPr>
        <p:spPr>
          <a:xfrm>
            <a:off x="8180982" y="517975"/>
            <a:ext cx="2468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B7FD4EA-44B0-4961-8517-CF0B1B34234C}"/>
              </a:ext>
            </a:extLst>
          </p:cNvPr>
          <p:cNvSpPr txBox="1"/>
          <p:nvPr/>
        </p:nvSpPr>
        <p:spPr>
          <a:xfrm>
            <a:off x="319760" y="3747357"/>
            <a:ext cx="109840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Western blotting of mitochondrion protein and cytosolic protein. (A) </a:t>
            </a:r>
            <a:r>
              <a:rPr lang="el-GR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ctin ;(B) VDAC 1; (C) COX IV.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4085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32</Words>
  <Application>Microsoft Office PowerPoint</Application>
  <PresentationFormat>宽屏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郭妮妮</dc:creator>
  <cp:lastModifiedBy>郭妮妮</cp:lastModifiedBy>
  <cp:revision>3</cp:revision>
  <dcterms:created xsi:type="dcterms:W3CDTF">2022-04-11T09:04:20Z</dcterms:created>
  <dcterms:modified xsi:type="dcterms:W3CDTF">2022-04-11T09:38:23Z</dcterms:modified>
</cp:coreProperties>
</file>